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53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86" d="100"/>
          <a:sy n="86" d="100"/>
        </p:scale>
        <p:origin x="120" y="6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591B6E-DD85-76F5-572D-5B283F611AE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0F97B54-B01C-F307-92B0-45FE54A302C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0C5D81-BE07-67FC-2412-361DF9F95F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616F01-3548-29AB-F0F8-9A1FDDCF77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36AA3C-E054-AC18-C6A8-97E162B4A0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96502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E470E5-35EB-A23A-2079-BB9871CDAF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C6362F4-D07B-1E1F-0961-5B36A78C19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1DB674-5B17-DD21-E71E-1E23E6FCC6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0775AD-5139-1CC2-AEEE-C7274F615B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FB8E08-27DA-4AF6-1F0A-387854ACBB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8522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FCE7323-38EA-D133-4522-CAB0A60EF48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B51A9B-4906-BAC8-5169-9C71FC2EB9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CF110F-2C3C-8FC7-F4F8-A43226068B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4BA0F0-1AAC-1D6D-E001-A5A21194D6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8FF68D-5A61-9352-0335-87C1A6761C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329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14FF59-D2FC-1A00-53D8-76A301DF1E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05ED88-C146-71E4-D52B-8A82D42D179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1300F5-F703-297B-FF23-5DC3EE62AA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C5522F-2E8A-C27A-513D-EF13B12F34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E3E46C-71B7-3B86-1E1F-BF18FC584C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04174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67590A-469A-54E1-15FE-C4DB0324F4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44BB84-F999-7B0C-2227-43FAD38FF3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EFFED6-3544-5224-8696-91BA07BBB3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1C4F66-8158-9CBB-61FA-EB7B13DC40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998BF8-2F7C-E9EE-6DF9-2EF54F1E9D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0122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3A97D0-45D6-CD76-511D-A234E84807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0BC010-D56B-1D68-89FA-062F874BA8A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27F600-0533-19EE-47B9-C4BA6369C7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72539F1-605E-EE35-73DD-09D18ED8AA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119D70-99CF-51DB-CE9D-9C8C7E5646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DA7AC8-40BF-3057-C590-18BE2C4128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087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213718-4BA8-D322-FF13-98AA9A9E54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535FE9-5C4B-17D7-BB59-A961C5EE7F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16250D9-6D6A-E6E5-471C-8002643ECC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943EF32-884B-EF2E-0979-42C0118DCE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7354C19-30FA-41EB-3C5C-6E4EED48544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B429C22-7D79-733B-9F9F-4EFE47ABFF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661135C-861B-AED4-E692-8020D4785C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BFCED44-FC99-C913-0FA5-85F87B8B5A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37704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6654DB-71D3-C547-4BA8-E0F93B3AEB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DDD4700-575A-9FB4-51DF-AFADC4602C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F4AFD67-5E06-90F9-5329-47574129B6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DBEF4F3-6800-CE73-182B-2858396C34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143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E581F51-4A85-AF76-7BC1-DE09A2DB2B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9EE7159-7E52-C584-D711-53A768BDD4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5CD1CC9-67EB-96A5-E90C-762130DFEE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60073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D631AF-32FB-F978-CD96-50E0B0E041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B1ED3B-01F5-CC44-95B6-1A15E1BC4CC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25EE9F9-6317-FC5F-538C-3ADF09AA73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8B52E2-379D-08BB-4BD0-66F920E03D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14F40B-2543-765E-DC0B-F82B19D46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22EB29-FC5F-C9FD-F09E-97A2D04FDE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1681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874128-E041-D9EA-D695-63D135E571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BFCE3E4-9E9A-02F4-7967-ACFB507F9EF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C12CA2C-E588-0949-E3D4-B06EC90D33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2FB69B-B3DA-0F22-B4F0-0976230EC2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BE11B9-7675-7A9A-A892-97CA47F4E1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2ADA8A-C690-6BC5-238F-81BF6D77D4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8729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A288017-75BD-C380-5C1F-6C0260E0AE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344FACF-2A33-D139-4804-40BB926BD7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5004FB-6988-09C4-218D-923AC21E201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9BBA40-421C-259A-884B-22367F06A1F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740E4E-11A4-F140-7277-1E982CA26FA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3649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1" name="Picture 120">
            <a:extLst>
              <a:ext uri="{FF2B5EF4-FFF2-40B4-BE49-F238E27FC236}">
                <a16:creationId xmlns:a16="http://schemas.microsoft.com/office/drawing/2014/main" id="{28EF42EC-E3A8-0F18-4174-C12CCCA27B2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9692" y="438653"/>
            <a:ext cx="11912616" cy="5980694"/>
          </a:xfrm>
          <a:prstGeom prst="rect">
            <a:avLst/>
          </a:prstGeom>
        </p:spPr>
      </p:pic>
      <p:sp>
        <p:nvSpPr>
          <p:cNvPr id="122" name="Rectangle 121">
            <a:extLst>
              <a:ext uri="{FF2B5EF4-FFF2-40B4-BE49-F238E27FC236}">
                <a16:creationId xmlns:a16="http://schemas.microsoft.com/office/drawing/2014/main" id="{651E08E2-CC99-E9A6-FC21-9C154F27780D}"/>
              </a:ext>
            </a:extLst>
          </p:cNvPr>
          <p:cNvSpPr/>
          <p:nvPr/>
        </p:nvSpPr>
        <p:spPr>
          <a:xfrm>
            <a:off x="2781300" y="6029325"/>
            <a:ext cx="209550" cy="2190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BF233777-A883-A128-9D62-B86538632FEA}"/>
              </a:ext>
            </a:extLst>
          </p:cNvPr>
          <p:cNvSpPr txBox="1"/>
          <p:nvPr/>
        </p:nvSpPr>
        <p:spPr>
          <a:xfrm>
            <a:off x="2676723" y="5975296"/>
            <a:ext cx="8706742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9. Ubiquitination assay. A) Absence of Snail binding to </a:t>
            </a:r>
            <a:r>
              <a:rPr lang="en-US" dirty="0" err="1"/>
              <a:t>gigaxonin</a:t>
            </a:r>
            <a:r>
              <a:rPr lang="en-US" dirty="0"/>
              <a:t>. B) Upregulation of NF-</a:t>
            </a:r>
            <a:r>
              <a:rPr lang="el-GR" dirty="0"/>
              <a:t>κ</a:t>
            </a:r>
            <a:r>
              <a:rPr lang="en-US" dirty="0"/>
              <a:t>B</a:t>
            </a:r>
          </a:p>
          <a:p>
            <a:r>
              <a:rPr lang="en-US" dirty="0"/>
              <a:t>With GAN siRNA, and C) higher ubiquitinated bands showing NF-kB binding to </a:t>
            </a:r>
            <a:r>
              <a:rPr lang="en-US" dirty="0" err="1"/>
              <a:t>gigaxonin</a:t>
            </a:r>
            <a:r>
              <a:rPr lang="en-US" dirty="0"/>
              <a:t> in </a:t>
            </a:r>
          </a:p>
          <a:p>
            <a:r>
              <a:rPr lang="en-US" dirty="0"/>
              <a:t>ME180 cells.</a:t>
            </a:r>
          </a:p>
        </p:txBody>
      </p:sp>
    </p:spTree>
    <p:extLst>
      <p:ext uri="{BB962C8B-B14F-4D97-AF65-F5344CB8AC3E}">
        <p14:creationId xmlns:p14="http://schemas.microsoft.com/office/powerpoint/2010/main" val="18655065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6</TotalTime>
  <Words>40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rivatsan, Eri S. (he/him/his)</dc:creator>
  <cp:lastModifiedBy>Srivatsan, Eri S. (he/him/his)</cp:lastModifiedBy>
  <cp:revision>18</cp:revision>
  <dcterms:created xsi:type="dcterms:W3CDTF">2024-02-09T21:19:49Z</dcterms:created>
  <dcterms:modified xsi:type="dcterms:W3CDTF">2024-02-09T22:46:08Z</dcterms:modified>
</cp:coreProperties>
</file>